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sldIdLst>
    <p:sldId id="256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7" r:id="rId19"/>
    <p:sldId id="273" r:id="rId20"/>
    <p:sldId id="274" r:id="rId21"/>
    <p:sldId id="275" r:id="rId22"/>
    <p:sldId id="276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30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7" r:id="rId53"/>
    <p:sldId id="308" r:id="rId54"/>
    <p:sldId id="309" r:id="rId55"/>
    <p:sldId id="310" r:id="rId56"/>
    <p:sldId id="311" r:id="rId57"/>
    <p:sldId id="312" r:id="rId58"/>
    <p:sldId id="313" r:id="rId59"/>
    <p:sldId id="314" r:id="rId60"/>
    <p:sldId id="315" r:id="rId61"/>
    <p:sldId id="316" r:id="rId62"/>
    <p:sldId id="317" r:id="rId63"/>
    <p:sldId id="318" r:id="rId64"/>
    <p:sldId id="319" r:id="rId65"/>
    <p:sldId id="320" r:id="rId66"/>
    <p:sldId id="321" r:id="rId67"/>
    <p:sldId id="322" r:id="rId68"/>
    <p:sldId id="323" r:id="rId69"/>
    <p:sldId id="324" r:id="rId70"/>
    <p:sldId id="331" r:id="rId71"/>
    <p:sldId id="325" r:id="rId72"/>
    <p:sldId id="326" r:id="rId73"/>
    <p:sldId id="327" r:id="rId74"/>
    <p:sldId id="328" r:id="rId75"/>
    <p:sldId id="329" r:id="rId76"/>
    <p:sldId id="330" r:id="rId7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4.xml"/><Relationship Id="rId21" Type="http://schemas.openxmlformats.org/officeDocument/2006/relationships/slide" Target="slides/slide19.xml"/><Relationship Id="rId42" Type="http://schemas.openxmlformats.org/officeDocument/2006/relationships/slide" Target="slides/slide40.xml"/><Relationship Id="rId47" Type="http://schemas.openxmlformats.org/officeDocument/2006/relationships/slide" Target="slides/slide45.xml"/><Relationship Id="rId63" Type="http://schemas.openxmlformats.org/officeDocument/2006/relationships/slide" Target="slides/slide61.xml"/><Relationship Id="rId68" Type="http://schemas.openxmlformats.org/officeDocument/2006/relationships/slide" Target="slides/slide66.xml"/><Relationship Id="rId16" Type="http://schemas.openxmlformats.org/officeDocument/2006/relationships/slide" Target="slides/slide14.xml"/><Relationship Id="rId11" Type="http://schemas.openxmlformats.org/officeDocument/2006/relationships/slide" Target="slides/slide9.xml"/><Relationship Id="rId32" Type="http://schemas.openxmlformats.org/officeDocument/2006/relationships/slide" Target="slides/slide30.xml"/><Relationship Id="rId37" Type="http://schemas.openxmlformats.org/officeDocument/2006/relationships/slide" Target="slides/slide35.xml"/><Relationship Id="rId53" Type="http://schemas.openxmlformats.org/officeDocument/2006/relationships/slide" Target="slides/slide51.xml"/><Relationship Id="rId58" Type="http://schemas.openxmlformats.org/officeDocument/2006/relationships/slide" Target="slides/slide56.xml"/><Relationship Id="rId74" Type="http://schemas.openxmlformats.org/officeDocument/2006/relationships/slide" Target="slides/slide72.xml"/><Relationship Id="rId79" Type="http://schemas.openxmlformats.org/officeDocument/2006/relationships/viewProps" Target="viewProps.xml"/><Relationship Id="rId5" Type="http://schemas.openxmlformats.org/officeDocument/2006/relationships/slide" Target="slides/slide3.xml"/><Relationship Id="rId61" Type="http://schemas.openxmlformats.org/officeDocument/2006/relationships/slide" Target="slides/slide59.xml"/><Relationship Id="rId19" Type="http://schemas.openxmlformats.org/officeDocument/2006/relationships/slide" Target="slides/slide1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slide" Target="slides/slide25.xml"/><Relationship Id="rId30" Type="http://schemas.openxmlformats.org/officeDocument/2006/relationships/slide" Target="slides/slide28.xml"/><Relationship Id="rId35" Type="http://schemas.openxmlformats.org/officeDocument/2006/relationships/slide" Target="slides/slide33.xml"/><Relationship Id="rId43" Type="http://schemas.openxmlformats.org/officeDocument/2006/relationships/slide" Target="slides/slide41.xml"/><Relationship Id="rId48" Type="http://schemas.openxmlformats.org/officeDocument/2006/relationships/slide" Target="slides/slide46.xml"/><Relationship Id="rId56" Type="http://schemas.openxmlformats.org/officeDocument/2006/relationships/slide" Target="slides/slide54.xml"/><Relationship Id="rId64" Type="http://schemas.openxmlformats.org/officeDocument/2006/relationships/slide" Target="slides/slide62.xml"/><Relationship Id="rId69" Type="http://schemas.openxmlformats.org/officeDocument/2006/relationships/slide" Target="slides/slide67.xml"/><Relationship Id="rId77" Type="http://schemas.openxmlformats.org/officeDocument/2006/relationships/slide" Target="slides/slide75.xml"/><Relationship Id="rId8" Type="http://schemas.openxmlformats.org/officeDocument/2006/relationships/slide" Target="slides/slide6.xml"/><Relationship Id="rId51" Type="http://schemas.openxmlformats.org/officeDocument/2006/relationships/slide" Target="slides/slide49.xml"/><Relationship Id="rId72" Type="http://schemas.openxmlformats.org/officeDocument/2006/relationships/slide" Target="slides/slide70.xml"/><Relationship Id="rId80" Type="http://schemas.openxmlformats.org/officeDocument/2006/relationships/theme" Target="theme/theme1.xml"/><Relationship Id="rId3" Type="http://schemas.openxmlformats.org/officeDocument/2006/relationships/slide" Target="slides/slide1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slide" Target="slides/slide23.xml"/><Relationship Id="rId33" Type="http://schemas.openxmlformats.org/officeDocument/2006/relationships/slide" Target="slides/slide31.xml"/><Relationship Id="rId38" Type="http://schemas.openxmlformats.org/officeDocument/2006/relationships/slide" Target="slides/slide36.xml"/><Relationship Id="rId46" Type="http://schemas.openxmlformats.org/officeDocument/2006/relationships/slide" Target="slides/slide44.xml"/><Relationship Id="rId59" Type="http://schemas.openxmlformats.org/officeDocument/2006/relationships/slide" Target="slides/slide57.xml"/><Relationship Id="rId67" Type="http://schemas.openxmlformats.org/officeDocument/2006/relationships/slide" Target="slides/slide65.xml"/><Relationship Id="rId20" Type="http://schemas.openxmlformats.org/officeDocument/2006/relationships/slide" Target="slides/slide18.xml"/><Relationship Id="rId41" Type="http://schemas.openxmlformats.org/officeDocument/2006/relationships/slide" Target="slides/slide39.xml"/><Relationship Id="rId54" Type="http://schemas.openxmlformats.org/officeDocument/2006/relationships/slide" Target="slides/slide52.xml"/><Relationship Id="rId62" Type="http://schemas.openxmlformats.org/officeDocument/2006/relationships/slide" Target="slides/slide60.xml"/><Relationship Id="rId70" Type="http://schemas.openxmlformats.org/officeDocument/2006/relationships/slide" Target="slides/slide68.xml"/><Relationship Id="rId75" Type="http://schemas.openxmlformats.org/officeDocument/2006/relationships/slide" Target="slides/slide73.xml"/><Relationship Id="rId1" Type="http://schemas.openxmlformats.org/officeDocument/2006/relationships/customXml" Target="../customXml/item1.xml"/><Relationship Id="rId6" Type="http://schemas.openxmlformats.org/officeDocument/2006/relationships/slide" Target="slides/slide4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slide" Target="slides/slide26.xml"/><Relationship Id="rId36" Type="http://schemas.openxmlformats.org/officeDocument/2006/relationships/slide" Target="slides/slide34.xml"/><Relationship Id="rId49" Type="http://schemas.openxmlformats.org/officeDocument/2006/relationships/slide" Target="slides/slide47.xml"/><Relationship Id="rId57" Type="http://schemas.openxmlformats.org/officeDocument/2006/relationships/slide" Target="slides/slide55.xml"/><Relationship Id="rId10" Type="http://schemas.openxmlformats.org/officeDocument/2006/relationships/slide" Target="slides/slide8.xml"/><Relationship Id="rId31" Type="http://schemas.openxmlformats.org/officeDocument/2006/relationships/slide" Target="slides/slide29.xml"/><Relationship Id="rId44" Type="http://schemas.openxmlformats.org/officeDocument/2006/relationships/slide" Target="slides/slide42.xml"/><Relationship Id="rId52" Type="http://schemas.openxmlformats.org/officeDocument/2006/relationships/slide" Target="slides/slide50.xml"/><Relationship Id="rId60" Type="http://schemas.openxmlformats.org/officeDocument/2006/relationships/slide" Target="slides/slide58.xml"/><Relationship Id="rId65" Type="http://schemas.openxmlformats.org/officeDocument/2006/relationships/slide" Target="slides/slide63.xml"/><Relationship Id="rId73" Type="http://schemas.openxmlformats.org/officeDocument/2006/relationships/slide" Target="slides/slide71.xml"/><Relationship Id="rId78" Type="http://schemas.openxmlformats.org/officeDocument/2006/relationships/presProps" Target="presProps.xml"/><Relationship Id="rId81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39" Type="http://schemas.openxmlformats.org/officeDocument/2006/relationships/slide" Target="slides/slide37.xml"/><Relationship Id="rId34" Type="http://schemas.openxmlformats.org/officeDocument/2006/relationships/slide" Target="slides/slide32.xml"/><Relationship Id="rId50" Type="http://schemas.openxmlformats.org/officeDocument/2006/relationships/slide" Target="slides/slide48.xml"/><Relationship Id="rId55" Type="http://schemas.openxmlformats.org/officeDocument/2006/relationships/slide" Target="slides/slide53.xml"/><Relationship Id="rId76" Type="http://schemas.openxmlformats.org/officeDocument/2006/relationships/slide" Target="slides/slide74.xml"/><Relationship Id="rId7" Type="http://schemas.openxmlformats.org/officeDocument/2006/relationships/slide" Target="slides/slide5.xml"/><Relationship Id="rId71" Type="http://schemas.openxmlformats.org/officeDocument/2006/relationships/slide" Target="slides/slide69.xml"/><Relationship Id="rId2" Type="http://schemas.openxmlformats.org/officeDocument/2006/relationships/slideMaster" Target="slideMasters/slideMaster1.xml"/><Relationship Id="rId29" Type="http://schemas.openxmlformats.org/officeDocument/2006/relationships/slide" Target="slides/slide27.xml"/><Relationship Id="rId24" Type="http://schemas.openxmlformats.org/officeDocument/2006/relationships/slide" Target="slides/slide22.xml"/><Relationship Id="rId40" Type="http://schemas.openxmlformats.org/officeDocument/2006/relationships/slide" Target="slides/slide38.xml"/><Relationship Id="rId45" Type="http://schemas.openxmlformats.org/officeDocument/2006/relationships/slide" Target="slides/slide43.xml"/><Relationship Id="rId66" Type="http://schemas.openxmlformats.org/officeDocument/2006/relationships/slide" Target="slides/slide6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163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197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777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4810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412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965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948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069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193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231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129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D770A-9580-4A76-B9AD-4F90244063B5}" type="datetimeFigureOut">
              <a:rPr lang="en-US" smtClean="0"/>
              <a:t>12/8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4EA16-2EF7-4FAD-9953-31C42F0C3D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673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9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2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5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8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1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4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7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0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image" Target="../media/image5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3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emf"/><Relationship Id="rId2" Type="http://schemas.openxmlformats.org/officeDocument/2006/relationships/image" Target="../media/image5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.em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2" Type="http://schemas.openxmlformats.org/officeDocument/2006/relationships/image" Target="../media/image5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9.e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emf"/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2.em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emf"/><Relationship Id="rId2" Type="http://schemas.openxmlformats.org/officeDocument/2006/relationships/image" Target="../media/image6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5.em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emf"/><Relationship Id="rId2" Type="http://schemas.openxmlformats.org/officeDocument/2006/relationships/image" Target="../media/image6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8.emf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emf"/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1.emf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emf"/><Relationship Id="rId2" Type="http://schemas.openxmlformats.org/officeDocument/2006/relationships/image" Target="../media/image7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4.em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emf"/><Relationship Id="rId2" Type="http://schemas.openxmlformats.org/officeDocument/2006/relationships/image" Target="../media/image7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7.emf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emf"/><Relationship Id="rId2" Type="http://schemas.openxmlformats.org/officeDocument/2006/relationships/image" Target="../media/image7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0.emf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emf"/><Relationship Id="rId2" Type="http://schemas.openxmlformats.org/officeDocument/2006/relationships/image" Target="../media/image8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3.em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emf"/><Relationship Id="rId2" Type="http://schemas.openxmlformats.org/officeDocument/2006/relationships/image" Target="../media/image8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.emf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emf"/><Relationship Id="rId2" Type="http://schemas.openxmlformats.org/officeDocument/2006/relationships/image" Target="../media/image8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9.emf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emf"/><Relationship Id="rId2" Type="http://schemas.openxmlformats.org/officeDocument/2006/relationships/image" Target="../media/image9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2.emf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emf"/><Relationship Id="rId2" Type="http://schemas.openxmlformats.org/officeDocument/2006/relationships/image" Target="../media/image9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5.emf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emf"/><Relationship Id="rId2" Type="http://schemas.openxmlformats.org/officeDocument/2006/relationships/image" Target="../media/image9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98.emf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0.emf"/><Relationship Id="rId2" Type="http://schemas.openxmlformats.org/officeDocument/2006/relationships/image" Target="../media/image9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1.emf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emf"/><Relationship Id="rId2" Type="http://schemas.openxmlformats.org/officeDocument/2006/relationships/image" Target="../media/image10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4.emf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emf"/><Relationship Id="rId2" Type="http://schemas.openxmlformats.org/officeDocument/2006/relationships/image" Target="../media/image10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7.emf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9.emf"/><Relationship Id="rId2" Type="http://schemas.openxmlformats.org/officeDocument/2006/relationships/image" Target="../media/image10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0.emf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2.emf"/><Relationship Id="rId2" Type="http://schemas.openxmlformats.org/officeDocument/2006/relationships/image" Target="../media/image11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3.emf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5.emf"/><Relationship Id="rId2" Type="http://schemas.openxmlformats.org/officeDocument/2006/relationships/image" Target="../media/image11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.emf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8.emf"/><Relationship Id="rId2" Type="http://schemas.openxmlformats.org/officeDocument/2006/relationships/image" Target="../media/image11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19.emf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1.emf"/><Relationship Id="rId2" Type="http://schemas.openxmlformats.org/officeDocument/2006/relationships/image" Target="../media/image12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2.emf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4.emf"/><Relationship Id="rId2" Type="http://schemas.openxmlformats.org/officeDocument/2006/relationships/image" Target="../media/image12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5.emf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7.emf"/><Relationship Id="rId2" Type="http://schemas.openxmlformats.org/officeDocument/2006/relationships/image" Target="../media/image12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28.emf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0.emf"/><Relationship Id="rId2" Type="http://schemas.openxmlformats.org/officeDocument/2006/relationships/image" Target="../media/image12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31.emf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3.emf"/><Relationship Id="rId2" Type="http://schemas.openxmlformats.org/officeDocument/2006/relationships/image" Target="../media/image13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34.emf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6.emf"/><Relationship Id="rId2" Type="http://schemas.openxmlformats.org/officeDocument/2006/relationships/image" Target="../media/image13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37.emf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9.emf"/><Relationship Id="rId2" Type="http://schemas.openxmlformats.org/officeDocument/2006/relationships/image" Target="../media/image13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0.emf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2.emf"/><Relationship Id="rId2" Type="http://schemas.openxmlformats.org/officeDocument/2006/relationships/image" Target="../media/image14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3.emf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5.emf"/><Relationship Id="rId2" Type="http://schemas.openxmlformats.org/officeDocument/2006/relationships/image" Target="../media/image14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.emf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8.emf"/><Relationship Id="rId2" Type="http://schemas.openxmlformats.org/officeDocument/2006/relationships/image" Target="../media/image14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49.emf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1.emf"/><Relationship Id="rId2" Type="http://schemas.openxmlformats.org/officeDocument/2006/relationships/image" Target="../media/image15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52.emf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4.emf"/><Relationship Id="rId2" Type="http://schemas.openxmlformats.org/officeDocument/2006/relationships/image" Target="../media/image15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55.emf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7.emf"/><Relationship Id="rId2" Type="http://schemas.openxmlformats.org/officeDocument/2006/relationships/image" Target="../media/image15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58.emf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0.emf"/><Relationship Id="rId2" Type="http://schemas.openxmlformats.org/officeDocument/2006/relationships/image" Target="../media/image15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61.emf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3.emf"/><Relationship Id="rId2" Type="http://schemas.openxmlformats.org/officeDocument/2006/relationships/image" Target="../media/image16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64.emf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6.emf"/><Relationship Id="rId2" Type="http://schemas.openxmlformats.org/officeDocument/2006/relationships/image" Target="../media/image16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67.emf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9.emf"/><Relationship Id="rId2" Type="http://schemas.openxmlformats.org/officeDocument/2006/relationships/image" Target="../media/image16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0.emf"/></Relationships>
</file>

<file path=ppt/slides/_rels/slide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2.emf"/><Relationship Id="rId2" Type="http://schemas.openxmlformats.org/officeDocument/2006/relationships/image" Target="../media/image17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3.emf"/></Relationships>
</file>

<file path=ppt/slides/_rels/slide5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5.emf"/><Relationship Id="rId2" Type="http://schemas.openxmlformats.org/officeDocument/2006/relationships/image" Target="../media/image17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.emf"/></Relationships>
</file>

<file path=ppt/slides/_rels/slide6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8.emf"/><Relationship Id="rId2" Type="http://schemas.openxmlformats.org/officeDocument/2006/relationships/image" Target="../media/image17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9.emf"/></Relationships>
</file>

<file path=ppt/slides/_rels/slide6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1.emf"/><Relationship Id="rId2" Type="http://schemas.openxmlformats.org/officeDocument/2006/relationships/image" Target="../media/image18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82.emf"/></Relationships>
</file>

<file path=ppt/slides/_rels/slide6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4.emf"/><Relationship Id="rId2" Type="http://schemas.openxmlformats.org/officeDocument/2006/relationships/image" Target="../media/image18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85.emf"/></Relationships>
</file>

<file path=ppt/slides/_rels/slide6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7.emf"/><Relationship Id="rId2" Type="http://schemas.openxmlformats.org/officeDocument/2006/relationships/image" Target="../media/image18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88.emf"/></Relationships>
</file>

<file path=ppt/slides/_rels/slide6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0.emf"/><Relationship Id="rId2" Type="http://schemas.openxmlformats.org/officeDocument/2006/relationships/image" Target="../media/image18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1.emf"/></Relationships>
</file>

<file path=ppt/slides/_rels/slide6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3.emf"/><Relationship Id="rId2" Type="http://schemas.openxmlformats.org/officeDocument/2006/relationships/image" Target="../media/image19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4.emf"/></Relationships>
</file>

<file path=ppt/slides/_rels/slide6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6.emf"/><Relationship Id="rId2" Type="http://schemas.openxmlformats.org/officeDocument/2006/relationships/image" Target="../media/image19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7.emf"/></Relationships>
</file>

<file path=ppt/slides/_rels/slide6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9.emf"/><Relationship Id="rId2" Type="http://schemas.openxmlformats.org/officeDocument/2006/relationships/image" Target="../media/image19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00.emf"/></Relationships>
</file>

<file path=ppt/slides/_rels/slide6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2.emf"/><Relationship Id="rId2" Type="http://schemas.openxmlformats.org/officeDocument/2006/relationships/image" Target="../media/image20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03.emf"/></Relationships>
</file>

<file path=ppt/slides/_rels/slide6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5.emf"/><Relationship Id="rId2" Type="http://schemas.openxmlformats.org/officeDocument/2006/relationships/image" Target="../media/image20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0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0.emf"/></Relationships>
</file>

<file path=ppt/slides/_rels/slide7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8.emf"/><Relationship Id="rId2" Type="http://schemas.openxmlformats.org/officeDocument/2006/relationships/image" Target="../media/image207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09.emf"/></Relationships>
</file>

<file path=ppt/slides/_rels/slide7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1.emf"/><Relationship Id="rId2" Type="http://schemas.openxmlformats.org/officeDocument/2006/relationships/image" Target="../media/image210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12.emf"/></Relationships>
</file>

<file path=ppt/slides/_rels/slide7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4.emf"/><Relationship Id="rId2" Type="http://schemas.openxmlformats.org/officeDocument/2006/relationships/image" Target="../media/image213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15.emf"/></Relationships>
</file>

<file path=ppt/slides/_rels/slide7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7.emf"/><Relationship Id="rId2" Type="http://schemas.openxmlformats.org/officeDocument/2006/relationships/image" Target="../media/image216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18.emf"/></Relationships>
</file>

<file path=ppt/slides/_rels/slide7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0.emf"/><Relationship Id="rId2" Type="http://schemas.openxmlformats.org/officeDocument/2006/relationships/image" Target="../media/image219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21.emf"/></Relationships>
</file>

<file path=ppt/slides/_rels/slide7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3.emf"/><Relationship Id="rId2" Type="http://schemas.openxmlformats.org/officeDocument/2006/relationships/image" Target="../media/image222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24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80730" y="186267"/>
            <a:ext cx="9144000" cy="961496"/>
          </a:xfrm>
        </p:spPr>
        <p:txBody>
          <a:bodyPr/>
          <a:lstStyle/>
          <a:p>
            <a:r>
              <a:rPr lang="en-US" dirty="0"/>
              <a:t>Phosphatidylethanolamine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91734" y="1147763"/>
            <a:ext cx="9144000" cy="1655762"/>
          </a:xfrm>
        </p:spPr>
        <p:txBody>
          <a:bodyPr/>
          <a:lstStyle/>
          <a:p>
            <a:r>
              <a:rPr lang="en-US" dirty="0"/>
              <a:t>12.15.2018 MALDI imaging of Parietal Cortex</a:t>
            </a:r>
          </a:p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519" y="1576267"/>
            <a:ext cx="7047881" cy="528173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03728" y="2423667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81742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18:4), PE(14:1/18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55607" y="5867399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84.4599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02368" y="5867399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22.4158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49130" y="5867399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06.441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861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2751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071005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0:0), PE(16:0/18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79407" y="5858933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20.553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858933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8.509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49459" y="5858933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2.535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38710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41291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0:1), PE(14:1/20:0), PE(16:0/18:1) , PE(16:1/18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70939" y="59182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8.538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9182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6.49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57927" y="59182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0.520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199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312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123117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0:2), PE(14:1/20:1), PE(16:0/18:2) , PE(16:1/18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37073" y="5698066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6.522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698066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4.478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91793" y="5698066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8.504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8932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2562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0:3), PE(14:1/20:2), PE(16:0/18:3) , PE(16:1/18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47140" y="55964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4.506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5964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2.462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81726" y="5596467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6.488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1194" y="1486067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26351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63924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0:4), PE(14:1/20:3), PE(16:0/18:4) , PE(16:1/18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55606" y="5748866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2.491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48866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0.447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73260" y="5748866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4.473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7454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6552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031809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0:5), PE(14:1/20:4), PE(16:1/18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0.475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8.431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2.4575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6552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847836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2:0), PE(16:0/20:0), PE(18:0/18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8.585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6.541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0.5670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199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3124" y="1568687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507411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2:1), PE(14:1/22:0), PE(16:0/20:1), PE(16:1/20:0), PE(18:0/18:1), PE(18:1/18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6.569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4.525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8.551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312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490847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2:2), PE(14:1/22:1), PE(16:0/20:2), PE(16:1/20:1), PE(18:0/18:2), PE(18:1/18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4.553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2.509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6.535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6552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1604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E(14:0/14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72633" y="6002866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36.4599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6002866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74.4158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72838" y="6002866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58.441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75662" y="13738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9235" y="13738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62089" y="13738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879907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2:3), PE(14:1/22:2), PE(16:0/20:3), PE(16:1/20:3), PE(18:0/18:3), PE(18:1/18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2.538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0.49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4.520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79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2803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105598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2:4), PE(14:1/22:3), PE(16:0/20:4), PE(16:1/20:3), PE(18:0/18:4), PE(18:1/18:3), PE(18:2/18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0.522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8.478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2.504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3124" y="16046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245593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2:5), PE(14:1/22:4), PE(16:0/20:5), PE(16:1/20:4), PE(18:1/18:4), PE(18:2/18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8.506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6.462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0.488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6068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36844" y="16046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795476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22:6), PE(14:1/22:5), PE(16:1/20:5), PE(18:2/18:4), PE(18:3/18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6.491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4.447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8.473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05749" y="13738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8932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556820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1/14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32.4286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70.3845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54.4105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192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312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60226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1/16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60.4599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98.4158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82.441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4115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77210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154151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1/18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82.444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20.400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04.4262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7589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6552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723274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1/20:5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08.4599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46.4158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0.441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15223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1/22:6), PE(18:3/18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4.475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2.431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6.4575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688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9708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676399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0/22:0), PE(18:0/20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6.616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4.572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8.5983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12369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E(14:0/14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38672" y="5943599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34.444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943599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72.400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90194" y="5935132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56.4262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495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3637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761552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0/22:1), PE(16:1/22:0), PE(18:0/20:1), PE(18:1/20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4.6007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2.5566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6.582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93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74106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781867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0/22:2), PE(16:1/22:1), PE(18:0/20:2), PE(18:1/20:1), PE(18:2/20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2.585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0.54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4.56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25547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6834342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0/22:3), PE(16:1/22:2), PE(18:0/20:3), PE(18:1/20:2), PE(18:2/20:1), PE(18:3/20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0.569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8.525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2.5514 Na+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4359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16966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2178060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0/22:4), PE(16:1/22:3), PE(18:0/20:4), PE(18:1/20:3), PE(18:2/20:2), PE(18:3/20:1), PE(18:4)/20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8.553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6.509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0.535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6481" y="1468765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8040364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0/22:5), PE(16:1/22:4), PE(18:0/20:5), PE(18:1/20:4), PE(18:2/20:3), PE(18:3/20:2), PE(18:4)/20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6.538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4.494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8.520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192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58549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16977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0/22:6), PE(16:1/22:5), PE(18:1/20:5), PE(18:2/20:4), PE(18:3/20:3), PE(18:4/20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4.522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2.478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6.504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8036" y="1600148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6848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9313112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6:1/22:6), PE(18:2/20:5), PE(18:3/20:4), PE(18:4/20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2.506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0.462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4.488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7174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6848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7824428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0/22:0), PE(20:0/20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4.6477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2.6036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6.6296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4107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38583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2293836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0/22:1), PE(18:1/22:0), PE(20:0/20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0733" y="5715000"/>
            <a:ext cx="136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2.6320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0.5879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4.6140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0998125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0/22:2), PE(18:1/22:1), PE(18:2/22:0) PE(20:0/20:2), PE(20:1/20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0.616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8.572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2.5983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24856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E(14:0/16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21739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64.491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02.447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498330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86.473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3744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87581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4145718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0/22:3), PE(18:1/22:2), PE(18:2/22:1), PE(18:3/22:0), PE(20:0/20:3), PE(20:1/20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8.6007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6.5566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0.582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2433435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0/22:4), PE(18:1/22:3), PE(18:2/22:2), PE(18:3/22:1), PE(18:4/22:0), PE(20:0/20:4), PE(20:1/20:3), PE(20:2/20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6.585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4.541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8.5670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932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7186724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0/22:5), PE(18:1/22:4), PE(18:2/22:3), PE(18:3/22:2) PE(18:4/20:1), PE(20:0/20:5), PE(20:1/20:4), PE(20:2/20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4.569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2.525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6.551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6046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0204385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0/22:6), PE(18:1/22:5), PE(18:2/22:4), PE(18:3/22:3) PE(18:4/20:2), PE(20:1/20:5), PE(20:2/20:4), PE(20:3/20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2.553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0.509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4.535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350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6046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1925953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1/22:6), PE(18:2/22:5), PE(18:3/22:4), PE(18:4/22:2) PE(20:2/20:5), PE(20:3/20:4)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0.538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8.494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2.520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6482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495003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2/22:6), PE(18:3/22:5), PE(18:4/22:4), PE(20:3/20:5), PE(20:4/20:4)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8.522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6.478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0.504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38671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652626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3/22:6), PE(18:4/22:5), PE(20:4/20:5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6.506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4.462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8.488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6355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2930591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4/22:6), PE(20:5/20:5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4.491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2.447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06.473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8420273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3/20:5), PE(18:4/20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60.491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8.447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2.473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273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5827417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4/20:5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8.475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96.431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80.4575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8062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38671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66783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E(14:0/16:1), PE(14:1/16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38673" y="57404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62.475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404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00.431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06795" y="57404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84.4575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6046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8251120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8:4/18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2.4599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70.4158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54.441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468765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0824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6707858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0/22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2.6790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0.6349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4.6609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93984" y="16046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853377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0/22:1), PE(20:1/22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0.6633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8.6192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2.6453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9708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7045889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0/22:2), PE(20:1/22:1), PE(20:2/22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8.6477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395383" y="5715000"/>
            <a:ext cx="14012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866.6036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0.6296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273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18793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3074886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0/22:3), PE(20:1/22:2), PE(20:2/22:1), PE(20:3/22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6.6320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4.5879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8.6140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89583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3265197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0/22:4), PE(20:1/22:3), PE(20:2/22:2), PE(20:3/22:1), PE(20:4/22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4.616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2.572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6.5983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6314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48610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3505121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0/22:5), PE(20:1/22:4), PE(20:2/22:3), PE(20:3/22:2), PE(20:4/22:1), PE(20:5/22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2.6007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0.5566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4.582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273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49219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25523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0/22:6), PE(20:1/22:5), PE(20:2/22:4), PE(20:3/22:3), PE(20:4/22:2), PE(20:5/22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20.585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8.541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2.5670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2627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3055711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1/22:6), PE(20:2/22:5), PE(20:3/22:4), PE(20:4/22:3), PE(20:5/22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8.569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6.525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0.551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0824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7960662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2/22:6), PE(20:3/22:5), PE(20:4/22:4), PE(20:5/22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6.553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4.509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8.535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14504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PE(14:0/18:0), PE(16:0/16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21740" y="5681133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92.522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681133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30.478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06797" y="5681133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4.504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007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604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8092688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3/22:6), PE(20:4/22:5), PE(20:5/22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4.538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2.494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6.520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273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58549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3569850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4/22:6), PE(20:5/22:5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2.522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0.478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4.504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273" y="1478704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38052" y="16046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9418626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0:5/22:6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10.506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8.462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2.488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7842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2609837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0/22:0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0.7103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98.6662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82.6922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5678876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0/22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8.6946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96.6505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80.6766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3273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346692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0/22:2), PE(22:1/22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6.6790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94.6349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8.6609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2444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0702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2986003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0/22:3), PE(22:1/22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4.6633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92.6192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6.6453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68401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4810184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0/22:4), PE(22:1/22:3), PE(22:2/22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2.6477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90.6036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4.6296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8305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6698730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0/22:5), PE(22:1/22:4), PE(22:2/22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0.6320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88.5879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872.6140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468765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0342877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0/22:6), PE(22:1/22:5), PE(22:2/22:4), PE(22:3/22:3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8.616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86.572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0.5983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28122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02351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18:1), PE(14:1/18:0), PE(16:1/16:0) , PE(16:0/16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322069" y="59266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90.506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9266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28.462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06797" y="5926667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2.4888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245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96048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9394534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1/22:6), PE(22:2/22:5), PE(22:3/22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6.6007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84.5566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8.582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78427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4900567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2/22:6), PE(22:3/22:5), PE(22:4/22:4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4.585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82.541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6.5670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1280" y="1508522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5996558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3/22:6), PE(22:4/22:5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2.5694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80.5253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4.551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6482" y="1468765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8674236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4/22:6), PE(22:5/22:5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40.5538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8.5097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2.5357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8996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6938055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5/22:6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8.5381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6.4940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60.520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0192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67792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0444460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22:6/22:6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36.522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715000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74.478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715000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58.5044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4501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0484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41095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18:2), PE(14:1/18:1), PE(16:1/16:1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213273" y="55218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88.4912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5218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26.4471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615593" y="5521867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10.4731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2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312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26367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ctr"/>
            <a:r>
              <a:rPr lang="en-US" sz="3200" dirty="0"/>
              <a:t>PE(14:0/18:3), PE(14:1/18:2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314873" y="58504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686.4755 H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14433" y="5850467"/>
            <a:ext cx="1363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24.4314 K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9513993" y="5850467"/>
            <a:ext cx="1529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708.4575 Na+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3000" y="1526200"/>
            <a:ext cx="2040675" cy="41104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28062" y="1526200"/>
            <a:ext cx="2040675" cy="4110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313124" y="1526200"/>
            <a:ext cx="2040675" cy="4110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211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TgzLjN8NzI3ODEwLzE0MS9FbnRyeVBhcnQvNDEyNjM0MDkxNHw0NjUuMjk5OTk5OTk5OTk5OTU=</eid>
  <version>1</version>
  <updated-at>2021-10-05T22:38:02-04:00</updated-at>
</LabArchives>
</file>

<file path=customXml/itemProps1.xml><?xml version="1.0" encoding="utf-8"?>
<ds:datastoreItem xmlns:ds="http://schemas.openxmlformats.org/officeDocument/2006/customXml" ds:itemID="{B2CF9387-F521-49B7-B82C-8E9050402667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941</TotalTime>
  <Words>1704</Words>
  <Application>Microsoft Macintosh PowerPoint</Application>
  <PresentationFormat>Widescreen</PresentationFormat>
  <Paragraphs>298</Paragraphs>
  <Slides>7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5</vt:i4>
      </vt:variant>
    </vt:vector>
  </HeadingPairs>
  <TitlesOfParts>
    <vt:vector size="79" baseType="lpstr">
      <vt:lpstr>Arial</vt:lpstr>
      <vt:lpstr>Calibri</vt:lpstr>
      <vt:lpstr>Calibri Light</vt:lpstr>
      <vt:lpstr>Office Theme</vt:lpstr>
      <vt:lpstr>Phosphatidylethanolamines</vt:lpstr>
      <vt:lpstr>PE(14:0/14:0)</vt:lpstr>
      <vt:lpstr>PE(14:0/14:1)</vt:lpstr>
      <vt:lpstr>PE(14:0/16:0)</vt:lpstr>
      <vt:lpstr>PE(14:0/16:1), PE(14:1/16:0)</vt:lpstr>
      <vt:lpstr>PE(14:0/18:0), PE(16:0/16:0)</vt:lpstr>
      <vt:lpstr>PE(14:0/18:1), PE(14:1/18:0), PE(16:1/16:0) , PE(16:0/16:1)</vt:lpstr>
      <vt:lpstr>PE(14:0/18:2), PE(14:1/18:1), PE(16:1/16:1)</vt:lpstr>
      <vt:lpstr>PE(14:0/18:3), PE(14:1/18:2)</vt:lpstr>
      <vt:lpstr>PE(14:0/18:4), PE(14:1/18:3)</vt:lpstr>
      <vt:lpstr>PE(14:0/20:0), PE(16:0/18:0)</vt:lpstr>
      <vt:lpstr>PE(14:0/20:1), PE(14:1/20:0), PE(16:0/18:1) , PE(16:1/18:0)</vt:lpstr>
      <vt:lpstr>PE(14:0/20:2), PE(14:1/20:1), PE(16:0/18:2) , PE(16:1/18:1)</vt:lpstr>
      <vt:lpstr>PE(14:0/20:3), PE(14:1/20:2), PE(16:0/18:3) , PE(16:1/18:2)</vt:lpstr>
      <vt:lpstr>PE(14:0/20:4), PE(14:1/20:3), PE(16:0/18:4) , PE(16:1/18:3)</vt:lpstr>
      <vt:lpstr>PE(14:0/20:5), PE(14:1/20:4), PE(16:1/18:4)</vt:lpstr>
      <vt:lpstr>PE(14:0/22:0), PE(16:0/20:0), PE(18:0/18:0)</vt:lpstr>
      <vt:lpstr>PE(14:0/22:1), PE(14:1/22:0), PE(16:0/20:1), PE(16:1/20:0), PE(18:0/18:1), PE(18:1/18:0)</vt:lpstr>
      <vt:lpstr>PE(14:0/22:2), PE(14:1/22:1), PE(16:0/20:2), PE(16:1/20:1), PE(18:0/18:2), PE(18:1/18:1)</vt:lpstr>
      <vt:lpstr>PE(14:0/22:3), PE(14:1/22:2), PE(16:0/20:3), PE(16:1/20:3), PE(18:0/18:3), PE(18:1/18:2)</vt:lpstr>
      <vt:lpstr>PE(14:0/22:4), PE(14:1/22:3), PE(16:0/20:4), PE(16:1/20:3), PE(18:0/18:4), PE(18:1/18:3), PE(18:2/18:2)</vt:lpstr>
      <vt:lpstr>PE(14:0/22:5), PE(14:1/22:4), PE(16:0/20:5), PE(16:1/20:4), PE(18:1/18:4), PE(18:2/18:3)</vt:lpstr>
      <vt:lpstr>PE(14:0/22:6), PE(14:1/22:5), PE(16:1/20:5), PE(18:2/18:4), PE(18:3/18:3)</vt:lpstr>
      <vt:lpstr>PE(14:1/14:1)</vt:lpstr>
      <vt:lpstr>PE(14:1/16:1)</vt:lpstr>
      <vt:lpstr>PE(14:1/18:4)</vt:lpstr>
      <vt:lpstr>PE(14:1/20:5)</vt:lpstr>
      <vt:lpstr>PE(14:1/22:6), PE(18:3/18:4)</vt:lpstr>
      <vt:lpstr>PE(16:0/22:0), PE(18:0/20:0)</vt:lpstr>
      <vt:lpstr>PE(16:0/22:1), PE(16:1/22:0), PE(18:0/20:1), PE(18:1/20:0)</vt:lpstr>
      <vt:lpstr>PE(16:0/22:2), PE(16:1/22:1), PE(18:0/20:2), PE(18:1/20:1), PE(18:2/20:0)</vt:lpstr>
      <vt:lpstr>PE(16:0/22:3), PE(16:1/22:2), PE(18:0/20:3), PE(18:1/20:2), PE(18:2/20:1), PE(18:3/20:0)</vt:lpstr>
      <vt:lpstr>PE(16:0/22:4), PE(16:1/22:3), PE(18:0/20:4), PE(18:1/20:3), PE(18:2/20:2), PE(18:3/20:1), PE(18:4)/20:0)</vt:lpstr>
      <vt:lpstr>PE(16:0/22:5), PE(16:1/22:4), PE(18:0/20:5), PE(18:1/20:4), PE(18:2/20:3), PE(18:3/20:2), PE(18:4)/20:1)</vt:lpstr>
      <vt:lpstr>PE(16:0/22:6), PE(16:1/22:5), PE(18:1/20:5), PE(18:2/20:4), PE(18:3/20:3), PE(18:4/20:2)</vt:lpstr>
      <vt:lpstr>PE(16:1/22:6), PE(18:2/20:5), PE(18:3/20:4), PE(18:4/20:3)</vt:lpstr>
      <vt:lpstr>PE(18:0/22:0), PE(20:0/20:0)</vt:lpstr>
      <vt:lpstr>PE(18:0/22:1), PE(18:1/22:0), PE(20:0/20:1)</vt:lpstr>
      <vt:lpstr>PE(18:0/22:2), PE(18:1/22:1), PE(18:2/22:0) PE(20:0/20:2), PE(20:1/20:1)</vt:lpstr>
      <vt:lpstr>PE(18:0/22:3), PE(18:1/22:2), PE(18:2/22:1), PE(18:3/22:0), PE(20:0/20:3), PE(20:1/20:2)</vt:lpstr>
      <vt:lpstr>PE(18:0/22:4), PE(18:1/22:3), PE(18:2/22:2), PE(18:3/22:1), PE(18:4/22:0), PE(20:0/20:4), PE(20:1/20:3), PE(20:2/20:2)</vt:lpstr>
      <vt:lpstr>PE(18:0/22:5), PE(18:1/22:4), PE(18:2/22:3), PE(18:3/22:2) PE(18:4/20:1), PE(20:0/20:5), PE(20:1/20:4), PE(20:2/20:3)</vt:lpstr>
      <vt:lpstr>PE(18:0/22:6), PE(18:1/22:5), PE(18:2/22:4), PE(18:3/22:3) PE(18:4/20:2), PE(20:1/20:5), PE(20:2/20:4), PE(20:3/20:3)</vt:lpstr>
      <vt:lpstr>PE(18:1/22:6), PE(18:2/22:5), PE(18:3/22:4), PE(18:4/22:2) PE(20:2/20:5), PE(20:3/20:4) </vt:lpstr>
      <vt:lpstr>PE(18:2/22:6), PE(18:3/22:5), PE(18:4/22:4), PE(20:3/20:5), PE(20:4/20:4) </vt:lpstr>
      <vt:lpstr>PE(18:3/22:6), PE(18:4/22:5), PE(20:4/20:5)</vt:lpstr>
      <vt:lpstr>PE(18:4/22:6), PE(20:5/20:5)</vt:lpstr>
      <vt:lpstr>PE(18:3/20:5), PE(18:4/20:4)</vt:lpstr>
      <vt:lpstr>PE(18:4/20:5)</vt:lpstr>
      <vt:lpstr>PE(18:4/18:4)</vt:lpstr>
      <vt:lpstr>PE(20:0/22:0)</vt:lpstr>
      <vt:lpstr>PE(20:0/22:1), PE(20:1/22:0)</vt:lpstr>
      <vt:lpstr>PE(20:0/22:2), PE(20:1/22:1), PE(20:2/22:0)</vt:lpstr>
      <vt:lpstr>PE(20:0/22:3), PE(20:1/22:2), PE(20:2/22:1), PE(20:3/22:0)</vt:lpstr>
      <vt:lpstr>PE(20:0/22:4), PE(20:1/22:3), PE(20:2/22:2), PE(20:3/22:1), PE(20:4/22:0)</vt:lpstr>
      <vt:lpstr>PE(20:0/22:5), PE(20:1/22:4), PE(20:2/22:3), PE(20:3/22:2), PE(20:4/22:1), PE(20:5/22:0)</vt:lpstr>
      <vt:lpstr>PE(20:0/22:6), PE(20:1/22:5), PE(20:2/22:4), PE(20:3/22:3), PE(20:4/22:2), PE(20:5/22:1)</vt:lpstr>
      <vt:lpstr>PE(20:1/22:6), PE(20:2/22:5), PE(20:3/22:4), PE(20:4/22:3), PE(20:5/22:2)</vt:lpstr>
      <vt:lpstr>PE(20:2/22:6), PE(20:3/22:5), PE(20:4/22:4), PE(20:5/22:3)</vt:lpstr>
      <vt:lpstr>PE(20:3/22:6), PE(20:4/22:5), PE(20:5/22:4)</vt:lpstr>
      <vt:lpstr>PE(20:4/22:6), PE(20:5/22:5)</vt:lpstr>
      <vt:lpstr>PE(20:5/22:6)</vt:lpstr>
      <vt:lpstr>PE(22:0/22:0)</vt:lpstr>
      <vt:lpstr>PE(22:0/22:1)</vt:lpstr>
      <vt:lpstr>PE(22:0/22:2), PE(22:1/22:1)</vt:lpstr>
      <vt:lpstr>PE(22:0/22:3), PE(22:1/22:2)</vt:lpstr>
      <vt:lpstr>PE(22:0/22:4), PE(22:1/22:3), PE(22:2/22:2)</vt:lpstr>
      <vt:lpstr>PE(22:0/22:5), PE(22:1/22:4), PE(22:2/22:3)</vt:lpstr>
      <vt:lpstr>PE(22:0/22:6), PE(22:1/22:5), PE(22:2/22:4), PE(22:3/22:3)</vt:lpstr>
      <vt:lpstr>PE(22:1/22:6), PE(22:2/22:5), PE(22:3/22:4)</vt:lpstr>
      <vt:lpstr>PE(22:2/22:6), PE(22:3/22:5), PE(22:4/22:4)</vt:lpstr>
      <vt:lpstr>PE(22:3/22:6), PE(22:4/22:5)</vt:lpstr>
      <vt:lpstr>PE(22:4/22:6), PE(22:5/22:5)</vt:lpstr>
      <vt:lpstr>PE(22:5/22:6)</vt:lpstr>
      <vt:lpstr>PE(22:6/22:6)</vt:lpstr>
    </vt:vector>
  </TitlesOfParts>
  <Company>Johns Hopkin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osphatidylcholines</dc:title>
  <dc:creator>Bumpus Lab</dc:creator>
  <cp:lastModifiedBy>Cory J. White</cp:lastModifiedBy>
  <cp:revision>116</cp:revision>
  <dcterms:created xsi:type="dcterms:W3CDTF">2021-06-10T09:20:33Z</dcterms:created>
  <dcterms:modified xsi:type="dcterms:W3CDTF">2021-12-08T15:39:57Z</dcterms:modified>
</cp:coreProperties>
</file>